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8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theme/theme8.xml" ContentType="application/vnd.openxmlformats-officedocument.theme+xml"/>
  <Override PartName="/ppt/_rels/presentation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87.xml.rels" ContentType="application/vnd.openxmlformats-package.relationships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</p:sldMasterIdLst>
  <p:sldIdLst>
    <p:sldId id="256" r:id="rId10"/>
    <p:sldId id="257" r:id="rId11"/>
    <p:sldId id="258" r:id="rId12"/>
    <p:sldId id="259" r:id="rId13"/>
    <p:sldId id="260" r:id="rId14"/>
    <p:sldId id="261" r:id="rId15"/>
    <p:sldId id="262" r:id="rId16"/>
    <p:sldId id="263" r:id="rId17"/>
    <p:sldId id="264" r:id="rId18"/>
    <p:sldId id="265" r:id="rId1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" Target="slides/slide1.xml"/><Relationship Id="rId11" Type="http://schemas.openxmlformats.org/officeDocument/2006/relationships/slide" Target="slides/slide2.xml"/><Relationship Id="rId12" Type="http://schemas.openxmlformats.org/officeDocument/2006/relationships/slide" Target="slides/slide3.xml"/><Relationship Id="rId13" Type="http://schemas.openxmlformats.org/officeDocument/2006/relationships/slide" Target="slides/slide4.xml"/><Relationship Id="rId14" Type="http://schemas.openxmlformats.org/officeDocument/2006/relationships/slide" Target="slides/slide5.xml"/><Relationship Id="rId15" Type="http://schemas.openxmlformats.org/officeDocument/2006/relationships/slide" Target="slides/slide6.xml"/><Relationship Id="rId16" Type="http://schemas.openxmlformats.org/officeDocument/2006/relationships/slide" Target="slides/slide7.xml"/><Relationship Id="rId17" Type="http://schemas.openxmlformats.org/officeDocument/2006/relationships/slide" Target="slides/slide8.xml"/><Relationship Id="rId18" Type="http://schemas.openxmlformats.org/officeDocument/2006/relationships/slide" Target="slides/slide9.xml"/><Relationship Id="rId19" Type="http://schemas.openxmlformats.org/officeDocument/2006/relationships/slide" Target="slides/slide10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56098-4A56-4332-8C06-289A1C8E6F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11A9E6-4C91-41E3-9679-0EEFE84EA2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5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6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98BF4-FEF8-4732-ADCD-31EB4C9D8DE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9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0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1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2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3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5765B8-DC47-491B-A065-84374E9675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A2ADAFF-946A-4468-AE9D-84CA7B0501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1D90F32-D9DD-46CE-B0F3-B8F04521876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26BDD35-EDC2-41AF-B753-C08DCCB7F96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CA410DB-E533-4FD9-87F9-4FC1040B31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4BC32FA-24C9-47B5-A7F4-6DDCE1EA6B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5E91011-9FAA-463D-9F27-02DC14202F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293C544-6C40-4FB4-8BCC-A5E30DDB61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816EF-9FD9-4297-973E-9D57D2B1BB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8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9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31FFF18-4584-41A0-9DF4-68AC8C37F2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AA537D1-CA2D-4C67-9517-C165EE355B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75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6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22C38B7-B7DD-42F7-A60E-BB43375AC4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1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0D94F09-BBC8-480F-B41C-C2E7C1178DF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7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88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D14D6F7-9C39-4967-BDA5-402D1F1DB3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05B46E81-4D6E-4DD8-8564-9E51F467189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5F0C4AF-3977-4A77-9688-128FB677F9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E5CD4D0-8B1A-4FD4-BB55-DB0E1FF236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0AEF238-D4F1-47F6-9F4D-81FD257E7B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78D0F7D-9C6B-4993-B2A3-E36D961063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6629E0-10A6-479E-8639-15C16D3C28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4470528-8D09-4E0C-A0B4-CF9FCB1C28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0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0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08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9094F8A-3A9E-4E57-BCF8-B74618C625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2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AD28F2D-C8A2-4E6F-9621-415BA13A66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5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6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DCACCD2-8E37-4EB0-B1B9-6F27D8A6A51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E6E7AE8-686F-4ACB-AC9E-CB317B9562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2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2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3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4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25C1154-4079-406E-A3DB-00311B683C6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2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7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8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29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0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1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AB38AEF-EC64-408A-97D9-97092274199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72A8088-C056-4FF0-B006-762B71A883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BABCF7D-E672-4090-9D94-10AAD69E1E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8D66BE6-404E-4D3A-8A6E-B229A57F19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BC9905-EE12-4A01-A65B-3CB9EC0A9FD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84F7C33-9AF7-4104-9BFA-B3466BD9A9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81722CCB-061D-4D83-8C2C-44C0089BC4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B71889F-67CF-46AA-B3AE-946B8492DD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5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2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3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16585CAC-39CA-4E5E-B091-E61ACD5B8D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55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6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57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CD71831-653A-49FA-87F3-6EEA7ABFB6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59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0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1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32F56E9-79CA-4E5F-A67B-1F9C23AEBE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6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4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D73A3A6-20C3-4D39-B63B-1864FD4A69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6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8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69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64F3696-9BCF-4A2D-BB79-CBBC933A05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7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2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3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4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5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76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4776124-529D-49CD-A907-F0703871BC6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B794DEC-5515-4875-9C35-35EFC60A68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7733A-42A5-46EF-B084-A45229F2CE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85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836EE2E-0099-4DC0-A7AA-7A56E8DA22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692DA4DF-9EF9-466B-8827-9E47FBBB2D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0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EDCFACA-B70A-4BBB-A24F-6A8EA1677F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A931769D-15F4-4D32-850D-2453150B1A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CF73938-2E71-4955-A80E-6F5B2FEB35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5FCB5CF-3819-442B-AEA3-98B257EDCF9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9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9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0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031D51C-12CF-4BCF-9CD1-B731984F6B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3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4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D0EB0A9-8659-48B1-9BDD-BF4AF7BF6B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D26E67D-074A-44EB-AB4C-9C68A1D3B3E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0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1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2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CDF6A6CF-AD59-4976-B0F0-245A85EDB5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74A824-9750-44CD-A48A-BFCEA6490C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14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5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6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7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8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19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89E62434-D325-4782-B2FA-7A72AE74A02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C3E650C-6855-4CEC-8E30-427904EAC2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AAE599D-0781-43C9-AFA7-67B283E2BD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FF039DD3-352E-43C3-A8E9-07F7A0A3D3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3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4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DE6DEC23-3CB8-43BA-ACE2-300B61A105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32F96C2-CA1C-4D7C-A076-C2B37688C3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EB275E6F-4C1A-462E-9C59-9D19FA0542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3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9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40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06F2ED7-D50D-45F7-981A-4F050286B7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42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43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44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A206F53-BE9C-4471-B31C-E1E3652DA4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4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4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48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4F63702-00D3-4819-8858-3D1CDB9E9A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BEDBD-43A1-497C-ADF3-C69960E0DF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50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51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EE81ABE-9AFA-4DCB-B0B4-4279CEAC630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53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54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55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56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2C1B59B9-7C70-41E5-86B4-7952BC5E453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5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59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60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61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62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63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4BACE60A-B93F-49B4-B58A-4D6ADDEE66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88ED99F3-0D0B-44A3-A70E-2F85AAAFE4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3605F4B-29AA-436F-A007-8B1B03294B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4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75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8A1CBDF-B808-4562-A7F2-F8467891976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77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78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4F651C3-D593-4365-AE45-6094217CC95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4609643-9E92-452D-BE28-313978C2CF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0CC63529-E259-49A0-80D8-BAC8FB9B93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82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83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84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294F09AE-9881-47FD-8F10-18C09C32A8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4D22C-7F8B-42B7-9272-5EE2C1F1B2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8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8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88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56719B2-1886-489C-888B-028EB63BF9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90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91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92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12C0409-B10B-4285-BA1F-F01A4051D5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94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95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6504D61-F1DA-4E0C-8CDC-643EAD4701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99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0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45FCF6D3-88BE-41D5-80AA-6CA47725EC3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5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6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07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6BCC3814-660C-4ECC-A3E6-F33F056D4A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136F4C3-85C0-454F-8103-723C411D099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 type="subTitle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06FFB482-84D8-479E-942B-12759573FE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19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DC001C0-677D-45E1-AA49-554AF26A57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2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22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62AD706-F0AF-4EE0-B791-E01A8C6ED9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1BD8FCD-A785-4A60-AB46-6E51DF3E8B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8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2A2D60-E2C8-496A-B3BB-E70C886E82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subTitle"/>
          </p:nvPr>
        </p:nvSpPr>
        <p:spPr>
          <a:xfrm>
            <a:off x="457200" y="152280"/>
            <a:ext cx="8229600" cy="459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CDCD170A-4C04-4FE5-A608-FB8F3CB958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2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27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28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47F407A-78E9-426C-82D6-14EF3C765E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30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31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32" name="PlaceHolder 4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86793C34-0215-439E-91D9-C339731CD81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35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36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D723A271-628A-40EE-AE3E-0871B60007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457200" y="3783600"/>
            <a:ext cx="822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FF58824C-0687-42A7-8BD6-4DCBA5F145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41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2" name="PlaceHolder 3"/>
          <p:cNvSpPr>
            <a:spLocks noGrp="1"/>
          </p:cNvSpPr>
          <p:nvPr>
            <p:ph/>
          </p:nvPr>
        </p:nvSpPr>
        <p:spPr>
          <a:xfrm>
            <a:off x="4674240" y="121896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3" name="PlaceHolder 4"/>
          <p:cNvSpPr>
            <a:spLocks noGrp="1"/>
          </p:cNvSpPr>
          <p:nvPr>
            <p:ph/>
          </p:nvPr>
        </p:nvSpPr>
        <p:spPr>
          <a:xfrm>
            <a:off x="45720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4" name="PlaceHolder 5"/>
          <p:cNvSpPr>
            <a:spLocks noGrp="1"/>
          </p:cNvSpPr>
          <p:nvPr>
            <p:ph/>
          </p:nvPr>
        </p:nvSpPr>
        <p:spPr>
          <a:xfrm>
            <a:off x="4674240" y="3783600"/>
            <a:ext cx="40158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1691DCF-CF59-4CA7-918D-B5A272E6D4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46" name="PlaceHolder 2"/>
          <p:cNvSpPr>
            <a:spLocks noGrp="1"/>
          </p:cNvSpPr>
          <p:nvPr>
            <p:ph/>
          </p:nvPr>
        </p:nvSpPr>
        <p:spPr>
          <a:xfrm>
            <a:off x="45720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7" name="PlaceHolder 3"/>
          <p:cNvSpPr>
            <a:spLocks noGrp="1"/>
          </p:cNvSpPr>
          <p:nvPr>
            <p:ph/>
          </p:nvPr>
        </p:nvSpPr>
        <p:spPr>
          <a:xfrm>
            <a:off x="323964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8" name="PlaceHolder 4"/>
          <p:cNvSpPr>
            <a:spLocks noGrp="1"/>
          </p:cNvSpPr>
          <p:nvPr>
            <p:ph/>
          </p:nvPr>
        </p:nvSpPr>
        <p:spPr>
          <a:xfrm>
            <a:off x="6022080" y="121896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49" name="PlaceHolder 5"/>
          <p:cNvSpPr>
            <a:spLocks noGrp="1"/>
          </p:cNvSpPr>
          <p:nvPr>
            <p:ph/>
          </p:nvPr>
        </p:nvSpPr>
        <p:spPr>
          <a:xfrm>
            <a:off x="45720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50" name="PlaceHolder 6"/>
          <p:cNvSpPr>
            <a:spLocks noGrp="1"/>
          </p:cNvSpPr>
          <p:nvPr>
            <p:ph/>
          </p:nvPr>
        </p:nvSpPr>
        <p:spPr>
          <a:xfrm>
            <a:off x="323964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51" name="PlaceHolder 7"/>
          <p:cNvSpPr>
            <a:spLocks noGrp="1"/>
          </p:cNvSpPr>
          <p:nvPr>
            <p:ph/>
          </p:nvPr>
        </p:nvSpPr>
        <p:spPr>
          <a:xfrm>
            <a:off x="6022080" y="3783600"/>
            <a:ext cx="2649600" cy="234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F8400E8-F28C-485C-8BF6-1A9C069EAD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400440" y="6356520"/>
            <a:ext cx="22892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464653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898360" y="6356520"/>
            <a:ext cx="3505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12360" y="6356520"/>
            <a:ext cx="198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CD497C-DF48-4F2D-A924-75F770CDBC51}" type="slidenum">
              <a:rPr b="0" lang="hr-HR" sz="1400" spc="-1" strike="noStrike">
                <a:solidFill>
                  <a:srgbClr val="464653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Ravni poveznik 27"/>
          <p:cNvSpPr/>
          <p:nvPr/>
        </p:nvSpPr>
        <p:spPr>
          <a:xfrm>
            <a:off x="457200" y="635328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Ravni poveznik 28"/>
          <p:cNvSpPr/>
          <p:nvPr/>
        </p:nvSpPr>
        <p:spPr>
          <a:xfrm>
            <a:off x="457200" y="114300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Jednakokračni trokut 9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ravokutnik 10"/>
          <p:cNvSpPr/>
          <p:nvPr/>
        </p:nvSpPr>
        <p:spPr>
          <a:xfrm>
            <a:off x="905040" y="3648240"/>
            <a:ext cx="7315200" cy="1279440"/>
          </a:xfrm>
          <a:prstGeom prst="rect">
            <a:avLst/>
          </a:prstGeom>
          <a:noFill/>
          <a:ln cap="rnd" w="6480">
            <a:solidFill>
              <a:srgbClr val="727ca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ravokutnik 11"/>
          <p:cNvSpPr/>
          <p:nvPr/>
        </p:nvSpPr>
        <p:spPr>
          <a:xfrm>
            <a:off x="914400" y="5048280"/>
            <a:ext cx="7315200" cy="685800"/>
          </a:xfrm>
          <a:prstGeom prst="rect">
            <a:avLst/>
          </a:prstGeom>
          <a:noFill/>
          <a:ln cap="rnd" w="6480">
            <a:solidFill>
              <a:srgbClr val="9fb8c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ravokutnik 12"/>
          <p:cNvSpPr/>
          <p:nvPr/>
        </p:nvSpPr>
        <p:spPr>
          <a:xfrm>
            <a:off x="905040" y="3648240"/>
            <a:ext cx="228600" cy="1279440"/>
          </a:xfrm>
          <a:prstGeom prst="rect">
            <a:avLst/>
          </a:prstGeom>
          <a:solidFill>
            <a:srgbClr val="727ca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ravokutnik 14"/>
          <p:cNvSpPr/>
          <p:nvPr/>
        </p:nvSpPr>
        <p:spPr>
          <a:xfrm>
            <a:off x="914400" y="5048280"/>
            <a:ext cx="228600" cy="685800"/>
          </a:xfrm>
          <a:prstGeom prst="rect">
            <a:avLst/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50" name="PlaceHolder 3"/>
          <p:cNvSpPr>
            <a:spLocks noGrp="1"/>
          </p:cNvSpPr>
          <p:nvPr>
            <p:ph type="dt" idx="4"/>
          </p:nvPr>
        </p:nvSpPr>
        <p:spPr>
          <a:xfrm>
            <a:off x="6400800" y="6354360"/>
            <a:ext cx="228600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464653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PlaceHolder 4"/>
          <p:cNvSpPr>
            <a:spLocks noGrp="1"/>
          </p:cNvSpPr>
          <p:nvPr>
            <p:ph type="ftr" idx="5"/>
          </p:nvPr>
        </p:nvSpPr>
        <p:spPr>
          <a:xfrm>
            <a:off x="2898360" y="6354360"/>
            <a:ext cx="347508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5"/>
          <p:cNvSpPr>
            <a:spLocks noGrp="1"/>
          </p:cNvSpPr>
          <p:nvPr>
            <p:ph type="sldNum" idx="6"/>
          </p:nvPr>
        </p:nvSpPr>
        <p:spPr>
          <a:xfrm>
            <a:off x="1215720" y="6354360"/>
            <a:ext cx="121932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7A14BF4-B5E2-4110-B2B5-EED2020F4198}" type="slidenum">
              <a:rPr b="0" lang="hr-HR" sz="1400" spc="-1" strike="noStrike">
                <a:solidFill>
                  <a:srgbClr val="464653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464653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ravokutnik 10"/>
          <p:cNvSpPr/>
          <p:nvPr/>
        </p:nvSpPr>
        <p:spPr>
          <a:xfrm>
            <a:off x="914400" y="2819520"/>
            <a:ext cx="7315200" cy="1279440"/>
          </a:xfrm>
          <a:prstGeom prst="rect">
            <a:avLst/>
          </a:prstGeom>
          <a:noFill/>
          <a:ln cap="rnd" w="6480">
            <a:solidFill>
              <a:srgbClr val="727ca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ravokutnik 11"/>
          <p:cNvSpPr/>
          <p:nvPr/>
        </p:nvSpPr>
        <p:spPr>
          <a:xfrm>
            <a:off x="914400" y="2819520"/>
            <a:ext cx="228600" cy="1279440"/>
          </a:xfrm>
          <a:prstGeom prst="rect">
            <a:avLst/>
          </a:prstGeom>
          <a:solidFill>
            <a:srgbClr val="727ca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dde9ec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dde9ec"/>
              </a:solidFill>
              <a:latin typeface="Bookman Old Style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ffffff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ffffff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 type="dt" idx="7"/>
          </p:nvPr>
        </p:nvSpPr>
        <p:spPr>
          <a:xfrm>
            <a:off x="6400800" y="6354360"/>
            <a:ext cx="228600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dde9ec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dde9ec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PlaceHolder 4"/>
          <p:cNvSpPr>
            <a:spLocks noGrp="1"/>
          </p:cNvSpPr>
          <p:nvPr>
            <p:ph type="ftr" idx="8"/>
          </p:nvPr>
        </p:nvSpPr>
        <p:spPr>
          <a:xfrm>
            <a:off x="2898360" y="6354360"/>
            <a:ext cx="347508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laceHolder 5"/>
          <p:cNvSpPr>
            <a:spLocks noGrp="1"/>
          </p:cNvSpPr>
          <p:nvPr>
            <p:ph type="sldNum" idx="9"/>
          </p:nvPr>
        </p:nvSpPr>
        <p:spPr>
          <a:xfrm>
            <a:off x="1069560" y="6354360"/>
            <a:ext cx="1521000" cy="36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dde9ec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99CCE4-0DE7-4992-A0F4-112ED0AA562A}" type="slidenum">
              <a:rPr b="0" lang="hr-HR" sz="1400" spc="-1" strike="noStrike">
                <a:solidFill>
                  <a:srgbClr val="dde9ec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Ravni poveznik 27"/>
          <p:cNvSpPr/>
          <p:nvPr/>
        </p:nvSpPr>
        <p:spPr>
          <a:xfrm>
            <a:off x="457200" y="635328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avni poveznik 28"/>
          <p:cNvSpPr/>
          <p:nvPr/>
        </p:nvSpPr>
        <p:spPr>
          <a:xfrm>
            <a:off x="457200" y="114300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Jednakokračni trokut 9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Jednakokračni trokut 10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37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38" name="PlaceHolder 3"/>
          <p:cNvSpPr>
            <a:spLocks noGrp="1"/>
          </p:cNvSpPr>
          <p:nvPr>
            <p:ph type="dt" idx="10"/>
          </p:nvPr>
        </p:nvSpPr>
        <p:spPr>
          <a:xfrm>
            <a:off x="6400440" y="6356520"/>
            <a:ext cx="22892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464653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PlaceHolder 4"/>
          <p:cNvSpPr>
            <a:spLocks noGrp="1"/>
          </p:cNvSpPr>
          <p:nvPr>
            <p:ph type="ftr" idx="11"/>
          </p:nvPr>
        </p:nvSpPr>
        <p:spPr>
          <a:xfrm>
            <a:off x="2898360" y="6356520"/>
            <a:ext cx="3505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5"/>
          <p:cNvSpPr>
            <a:spLocks noGrp="1"/>
          </p:cNvSpPr>
          <p:nvPr>
            <p:ph type="sldNum" idx="12"/>
          </p:nvPr>
        </p:nvSpPr>
        <p:spPr>
          <a:xfrm>
            <a:off x="612360" y="6356520"/>
            <a:ext cx="198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4C70BDC-E744-436C-989D-DF7D036D7011}" type="slidenum">
              <a:rPr b="0" lang="hr-HR" sz="1400" spc="-1" strike="noStrike">
                <a:solidFill>
                  <a:srgbClr val="464653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Ravni poveznik 10"/>
          <p:cNvSpPr/>
          <p:nvPr/>
        </p:nvSpPr>
        <p:spPr>
          <a:xfrm>
            <a:off x="457200" y="635328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Jednakokračni trokut 11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181" name="PlaceHolder 3"/>
          <p:cNvSpPr>
            <a:spLocks noGrp="1"/>
          </p:cNvSpPr>
          <p:nvPr>
            <p:ph type="dt" idx="13"/>
          </p:nvPr>
        </p:nvSpPr>
        <p:spPr>
          <a:xfrm>
            <a:off x="6400440" y="6356520"/>
            <a:ext cx="22892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464653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PlaceHolder 4"/>
          <p:cNvSpPr>
            <a:spLocks noGrp="1"/>
          </p:cNvSpPr>
          <p:nvPr>
            <p:ph type="ftr" idx="14"/>
          </p:nvPr>
        </p:nvSpPr>
        <p:spPr>
          <a:xfrm>
            <a:off x="2898360" y="6356520"/>
            <a:ext cx="3505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5"/>
          <p:cNvSpPr>
            <a:spLocks noGrp="1"/>
          </p:cNvSpPr>
          <p:nvPr>
            <p:ph type="sldNum" idx="15"/>
          </p:nvPr>
        </p:nvSpPr>
        <p:spPr>
          <a:xfrm>
            <a:off x="612360" y="6356520"/>
            <a:ext cx="198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862F7E-C335-44DA-8160-28DC2819893D}" type="slidenum">
              <a:rPr b="0" lang="hr-HR" sz="1400" spc="-1" strike="noStrike">
                <a:solidFill>
                  <a:srgbClr val="464653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Ravni poveznik 10"/>
          <p:cNvSpPr/>
          <p:nvPr/>
        </p:nvSpPr>
        <p:spPr>
          <a:xfrm>
            <a:off x="457200" y="635328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avni poveznik 11"/>
          <p:cNvSpPr/>
          <p:nvPr/>
        </p:nvSpPr>
        <p:spPr>
          <a:xfrm>
            <a:off x="6178680" y="306360"/>
            <a:ext cx="0" cy="603576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Jednakokračni trokut 12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 type="dt" idx="16"/>
          </p:nvPr>
        </p:nvSpPr>
        <p:spPr>
          <a:xfrm>
            <a:off x="6400440" y="6356520"/>
            <a:ext cx="22892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464653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 type="ftr" idx="17"/>
          </p:nvPr>
        </p:nvSpPr>
        <p:spPr>
          <a:xfrm>
            <a:off x="2898360" y="6356520"/>
            <a:ext cx="3505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PlaceHolder 5"/>
          <p:cNvSpPr>
            <a:spLocks noGrp="1"/>
          </p:cNvSpPr>
          <p:nvPr>
            <p:ph type="sldNum" idx="18"/>
          </p:nvPr>
        </p:nvSpPr>
        <p:spPr>
          <a:xfrm>
            <a:off x="612360" y="6356520"/>
            <a:ext cx="198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47A241-12FF-43AE-BC06-5CE28818EF7D}" type="slidenum">
              <a:rPr b="0" lang="hr-HR" sz="1400" spc="-1" strike="noStrike">
                <a:solidFill>
                  <a:srgbClr val="464653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464653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Ravni poveznik 10"/>
          <p:cNvSpPr/>
          <p:nvPr/>
        </p:nvSpPr>
        <p:spPr>
          <a:xfrm>
            <a:off x="457200" y="635328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Jednakokračni trokut 11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ravokutnik 12"/>
          <p:cNvSpPr/>
          <p:nvPr/>
        </p:nvSpPr>
        <p:spPr>
          <a:xfrm>
            <a:off x="457200" y="500040"/>
            <a:ext cx="182520" cy="685800"/>
          </a:xfrm>
          <a:prstGeom prst="rect">
            <a:avLst/>
          </a:prstGeom>
          <a:solidFill>
            <a:srgbClr val="727ca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dde9ec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dde9ec"/>
              </a:solidFill>
              <a:latin typeface="Bookman Old Style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ffffff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ffffff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ffffff"/>
              </a:solidFill>
              <a:latin typeface="Gill Sans MT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 type="dt" idx="19"/>
          </p:nvPr>
        </p:nvSpPr>
        <p:spPr>
          <a:xfrm>
            <a:off x="6400440" y="6356520"/>
            <a:ext cx="22892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dde9ec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dde9ec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0" name="PlaceHolder 4"/>
          <p:cNvSpPr>
            <a:spLocks noGrp="1"/>
          </p:cNvSpPr>
          <p:nvPr>
            <p:ph type="ftr" idx="20"/>
          </p:nvPr>
        </p:nvSpPr>
        <p:spPr>
          <a:xfrm>
            <a:off x="2898360" y="6356520"/>
            <a:ext cx="3505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5"/>
          <p:cNvSpPr>
            <a:spLocks noGrp="1"/>
          </p:cNvSpPr>
          <p:nvPr>
            <p:ph type="sldNum" idx="21"/>
          </p:nvPr>
        </p:nvSpPr>
        <p:spPr>
          <a:xfrm>
            <a:off x="612360" y="6356520"/>
            <a:ext cx="198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dde9ec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E817F0C-DCE2-4583-92AC-54779E38BD8A}" type="slidenum">
              <a:rPr b="0" lang="hr-HR" sz="1400" spc="-1" strike="noStrike">
                <a:solidFill>
                  <a:srgbClr val="dde9ec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Ravni poveznik 10"/>
          <p:cNvSpPr/>
          <p:nvPr/>
        </p:nvSpPr>
        <p:spPr>
          <a:xfrm>
            <a:off x="457200" y="6353280"/>
            <a:ext cx="8229600" cy="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Jednakokračni trokut 11"/>
          <p:cNvSpPr/>
          <p:nvPr/>
        </p:nvSpPr>
        <p:spPr>
          <a:xfrm rot="5400000">
            <a:off x="418680" y="6467400"/>
            <a:ext cx="190440" cy="120600"/>
          </a:xfrm>
          <a:prstGeom prst="triangle">
            <a:avLst>
              <a:gd name="adj" fmla="val 50000"/>
            </a:avLst>
          </a:prstGeom>
          <a:solidFill>
            <a:srgbClr val="9fb8c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Ravni poveznik 12"/>
          <p:cNvSpPr/>
          <p:nvPr/>
        </p:nvSpPr>
        <p:spPr>
          <a:xfrm>
            <a:off x="6556320" y="276120"/>
            <a:ext cx="0" cy="5851800"/>
          </a:xfrm>
          <a:prstGeom prst="line">
            <a:avLst/>
          </a:prstGeom>
          <a:ln w="9360">
            <a:solidFill>
              <a:srgbClr val="9fb8cd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Click to edit the title text format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12" name="PlaceHolder 2"/>
          <p:cNvSpPr>
            <a:spLocks noGrp="1"/>
          </p:cNvSpPr>
          <p:nvPr>
            <p:ph type="body"/>
          </p:nvPr>
        </p:nvSpPr>
        <p:spPr>
          <a:xfrm>
            <a:off x="457200" y="1218960"/>
            <a:ext cx="8229600" cy="4910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601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2" marL="822240" indent="-228600">
              <a:spcBef>
                <a:spcPts val="601"/>
              </a:spcBef>
              <a:buClr>
                <a:srgbClr val="bcbcbc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3" marL="1096920" indent="-228600">
              <a:spcBef>
                <a:spcPts val="601"/>
              </a:spcBef>
              <a:buClr>
                <a:srgbClr val="8ba2b4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4" marL="1371600" indent="-228600">
              <a:spcBef>
                <a:spcPts val="601"/>
              </a:spcBef>
              <a:buClr>
                <a:srgbClr val="9fb8cd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5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6" marL="1371600" indent="-228600">
              <a:spcBef>
                <a:spcPts val="601"/>
              </a:spcBef>
              <a:buClr>
                <a:srgbClr val="000000"/>
              </a:buClr>
              <a:buSzPct val="70000"/>
              <a:buFont typeface="Wingdings" charset="2"/>
              <a:buChar char="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13" name="PlaceHolder 3"/>
          <p:cNvSpPr>
            <a:spLocks noGrp="1"/>
          </p:cNvSpPr>
          <p:nvPr>
            <p:ph type="dt" idx="22"/>
          </p:nvPr>
        </p:nvSpPr>
        <p:spPr>
          <a:xfrm>
            <a:off x="6400440" y="6356520"/>
            <a:ext cx="22892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sr-Latn-CS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sr-Latn-CS" sz="1400" spc="-1" strike="noStrike">
                <a:solidFill>
                  <a:srgbClr val="464653"/>
                </a:solidFill>
                <a:latin typeface="Gill Sans MT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4" name="PlaceHolder 4"/>
          <p:cNvSpPr>
            <a:spLocks noGrp="1"/>
          </p:cNvSpPr>
          <p:nvPr>
            <p:ph type="ftr" idx="23"/>
          </p:nvPr>
        </p:nvSpPr>
        <p:spPr>
          <a:xfrm>
            <a:off x="2898360" y="6356520"/>
            <a:ext cx="35053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5"/>
          <p:cNvSpPr>
            <a:spLocks noGrp="1"/>
          </p:cNvSpPr>
          <p:nvPr>
            <p:ph type="sldNum" idx="24"/>
          </p:nvPr>
        </p:nvSpPr>
        <p:spPr>
          <a:xfrm>
            <a:off x="612360" y="6356520"/>
            <a:ext cx="198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r-HR" sz="1400" spc="-1" strike="noStrike">
                <a:solidFill>
                  <a:srgbClr val="464653"/>
                </a:solidFill>
                <a:latin typeface="Gill Sans MT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F745B7-3C71-40DC-8D8F-4803D4618C39}" type="slidenum">
              <a:rPr b="0" lang="hr-HR" sz="1400" spc="-1" strike="noStrike">
                <a:solidFill>
                  <a:srgbClr val="464653"/>
                </a:solidFill>
                <a:latin typeface="Gill Sans MT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3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2" name="PlaceHolder 1"/>
          <p:cNvSpPr>
            <a:spLocks noGrp="1"/>
          </p:cNvSpPr>
          <p:nvPr>
            <p:ph type="title"/>
          </p:nvPr>
        </p:nvSpPr>
        <p:spPr>
          <a:xfrm>
            <a:off x="1219320" y="3886200"/>
            <a:ext cx="6858000" cy="9907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Bookman Old Style"/>
              </a:rPr>
              <a:t>Injury occurrence and injury consequences among Croatian football referees</a:t>
            </a:r>
            <a:endParaRPr b="0" lang="en-US" sz="24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53" name="PlaceHolder 2"/>
          <p:cNvSpPr>
            <a:spLocks noGrp="1"/>
          </p:cNvSpPr>
          <p:nvPr>
            <p:ph type="subTitle"/>
          </p:nvPr>
        </p:nvSpPr>
        <p:spPr>
          <a:xfrm>
            <a:off x="1219320" y="5124240"/>
            <a:ext cx="6858000" cy="5331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 algn="r">
              <a:lnSpc>
                <a:spcPct val="10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464653"/>
                </a:solidFill>
                <a:latin typeface="Bookman Old Style"/>
              </a:rPr>
              <a:t>Research project with practical application</a:t>
            </a:r>
            <a:endParaRPr b="0" lang="en-US" sz="2000" spc="-1" strike="noStrike">
              <a:solidFill>
                <a:srgbClr val="000000"/>
              </a:solidFill>
              <a:latin typeface="Gill Sans MT"/>
            </a:endParaRPr>
          </a:p>
          <a:p>
            <a:pPr indent="0" algn="r">
              <a:lnSpc>
                <a:spcPct val="10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Finally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74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ake your time!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Gill Sans MT"/>
              </a:rPr>
              <a:t>THE EXAMINER (GG) WILL BE AT YOUR DISPOSAL FOR ANY MISUNDERSTANDINGS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Gill Sans MT"/>
              </a:rPr>
              <a:t>PLEASE CALL IF THERE IS ANYTHING YOU HAVE TO CLEAR!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ank you for your cooperation!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The purpose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55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is study is designed with the aim to determine the injuries and complaints you have suffered as a direct and indirect consequence of soccer refereeing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Generally, the collected data will be used in order to: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efine the most common injuries you have suffered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efine the consequences of injuries (recovery, missed matches, etc.)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efine the factors related to injury occurrence (protective/risk factors of injury)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6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Important!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57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Participation is anonymous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No personal data will be asked (date of birth, city of residence, etc.)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Participation is voluntary and you can withdraw from the study with no explanation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We have no intention to connect the data with “you” (the person)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The returning of the fulfilled questionnaire will be considered as your informed consent for the study participation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We will ask you for 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59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Injuries and complaints which occurred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uring the last game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uring the last year (12 months)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uring your career (since you earned your refereeing license)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  <a:p>
            <a:pPr lvl="1" marL="547560" indent="-272880">
              <a:spcBef>
                <a:spcPts val="499"/>
              </a:spcBef>
              <a:buClr>
                <a:srgbClr val="9fb8cd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300" spc="-1" strike="noStrike">
                <a:solidFill>
                  <a:srgbClr val="464653"/>
                </a:solidFill>
                <a:latin typeface="Gill Sans MT"/>
              </a:rPr>
              <a:t>During fitness testing</a:t>
            </a:r>
            <a:endParaRPr b="0" lang="en-US" sz="2300" spc="-1" strike="noStrike">
              <a:solidFill>
                <a:srgbClr val="464653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3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0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For most of the questions …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61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Multiple choice answers are provided (a-b-c, yes-no, etc.)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You can leave questions unanswered if you do not feel comfortable to answer.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Gill Sans MT"/>
              </a:rPr>
              <a:t>If you do not understand the question, and/or not sure about the meanings, ask for the explanation please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Please read all provided answers before choosing the proper one!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In some cases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63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If you answer NO you will have to skip some questions (mostly the whole page), and go to another section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But please do not answer NO if this is not the case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4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INJURY?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65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Consider injury as: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600" spc="-1" strike="noStrike">
                <a:solidFill>
                  <a:srgbClr val="000000"/>
                </a:solidFill>
                <a:latin typeface="Gill Sans MT"/>
              </a:rPr>
              <a:t>	</a:t>
            </a:r>
            <a:r>
              <a:rPr b="1" lang="en-US" sz="2600" spc="-1" strike="noStrike">
                <a:solidFill>
                  <a:srgbClr val="000000"/>
                </a:solidFill>
                <a:latin typeface="Gill Sans MT"/>
              </a:rPr>
              <a:t>ANY PHYSICAL COMPLAINT SUSTAINED THAT RESULT FROM A REFEREEING AND TRAINING, IRRESPECTIVE OF THE NEED FOR MEDICAL ATTENTION OR TIME LOSS FROM ACTIVITY (REFEREEING OR TRAINING)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PlaceHolder 1"/>
          <p:cNvSpPr>
            <a:spLocks noGrp="1"/>
          </p:cNvSpPr>
          <p:nvPr>
            <p:ph type="title"/>
          </p:nvPr>
        </p:nvSpPr>
        <p:spPr>
          <a:xfrm>
            <a:off x="457200" y="228600"/>
            <a:ext cx="8229600" cy="9144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OVERUSE vs. TRAUMA?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67" name="PlaceHolder 2"/>
          <p:cNvSpPr>
            <a:spLocks noGrp="1"/>
          </p:cNvSpPr>
          <p:nvPr>
            <p:ph/>
          </p:nvPr>
        </p:nvSpPr>
        <p:spPr>
          <a:xfrm>
            <a:off x="456840" y="1285560"/>
            <a:ext cx="4040280" cy="685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9fb8cd"/>
                </a:solidFill>
                <a:latin typeface="Gill Sans MT"/>
              </a:rPr>
              <a:t>TRAUMA – ACUTE INJURY</a:t>
            </a:r>
            <a:endParaRPr b="0" lang="en-US" sz="24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68" name="PlaceHolder 3"/>
          <p:cNvSpPr>
            <a:spLocks noGrp="1"/>
          </p:cNvSpPr>
          <p:nvPr>
            <p:ph/>
          </p:nvPr>
        </p:nvSpPr>
        <p:spPr>
          <a:xfrm>
            <a:off x="4647960" y="1294920"/>
            <a:ext cx="4041720" cy="68580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rmAutofit/>
          </a:bodyPr>
          <a:p>
            <a:pPr indent="0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9fb8cd"/>
                </a:solidFill>
                <a:latin typeface="Gill Sans MT"/>
              </a:rPr>
              <a:t>OVERUSE INJURY</a:t>
            </a:r>
            <a:endParaRPr b="0" lang="en-US" sz="24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69" name=""/>
          <p:cNvSpPr txBox="1"/>
          <p:nvPr/>
        </p:nvSpPr>
        <p:spPr>
          <a:xfrm>
            <a:off x="457200" y="2133720"/>
            <a:ext cx="4038480" cy="4038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Occur as the result of a single, traumatic event (contact, fall, etc.).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Examples: fractures, ankle sprains, joint dislocation, concusion, hamstring muscle strain, etc.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  <p:sp>
        <p:nvSpPr>
          <p:cNvPr id="370" name=""/>
          <p:cNvSpPr txBox="1"/>
          <p:nvPr/>
        </p:nvSpPr>
        <p:spPr>
          <a:xfrm>
            <a:off x="4648320" y="2133720"/>
            <a:ext cx="4038480" cy="403848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Usually occur over time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Result of repetitive micro-trauma to the tendons, bones and joints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Examples: achilles tendinitis, bursitis, shin splints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1" name="PlaceHolder 1"/>
          <p:cNvSpPr>
            <a:spLocks noGrp="1"/>
          </p:cNvSpPr>
          <p:nvPr>
            <p:ph type="title"/>
          </p:nvPr>
        </p:nvSpPr>
        <p:spPr>
          <a:xfrm>
            <a:off x="457200" y="152280"/>
            <a:ext cx="8229600" cy="99072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464653"/>
                </a:solidFill>
                <a:latin typeface="Bookman Old Style"/>
              </a:rPr>
              <a:t>Practical application of the investigation</a:t>
            </a:r>
            <a:endParaRPr b="0" lang="en-US" sz="3200" spc="-1" strike="noStrike">
              <a:solidFill>
                <a:srgbClr val="464653"/>
              </a:solidFill>
              <a:latin typeface="Bookman Old Style"/>
            </a:endParaRPr>
          </a:p>
        </p:txBody>
      </p:sp>
      <p:sp>
        <p:nvSpPr>
          <p:cNvPr id="372" name=""/>
          <p:cNvSpPr txBox="1"/>
          <p:nvPr/>
        </p:nvSpPr>
        <p:spPr>
          <a:xfrm>
            <a:off x="457200" y="1219320"/>
            <a:ext cx="8229600" cy="4937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72880" indent="-272880">
              <a:spcBef>
                <a:spcPts val="601"/>
              </a:spcBef>
              <a:buClr>
                <a:srgbClr val="727ca3"/>
              </a:buClr>
              <a:buSzPct val="76000"/>
              <a:buFont typeface="Wingdings 3" charset="2"/>
              <a:buChar char="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Gill Sans MT"/>
              </a:rPr>
              <a:t>All data will be presented on the future seminars where we will provide you with some ideas how to reduce the injury occurrence and improve the recovery </a:t>
            </a:r>
            <a:endParaRPr b="0" lang="en-US" sz="2600" spc="-1" strike="noStrike">
              <a:solidFill>
                <a:srgbClr val="000000"/>
              </a:solidFill>
              <a:latin typeface="Gill Sans MT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2T13:11:52Z</dcterms:created>
  <dc:creator>Admin</dc:creator>
  <dc:description/>
  <dc:language>en-US</dc:language>
  <cp:lastModifiedBy>Admin</cp:lastModifiedBy>
  <dcterms:modified xsi:type="dcterms:W3CDTF">2013-02-06T13:00:44Z</dcterms:modified>
  <cp:revision>10</cp:revision>
  <dc:subject/>
  <dc:title>Injury status among Croatian football referees</dc:title>
</cp:coreProperties>
</file>